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F3A38E-C721-45C5-B896-7F7C03202C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7D6B52-2354-4056-943B-46F039C747B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B84A85-33E9-4973-B475-FDBEAC0A81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6A7EC6-251D-4A4D-8B3F-152DFFD9652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73A0CE-176E-4642-A04B-9FB7B8F1993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F7784C-FC0E-4B0E-946E-CFFD32635F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0DC1F9-2CD5-4F7D-88E0-915B05FAA7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DC8B30-A21C-4DAB-8A57-FFFD96E21D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95273-6ED9-4363-B2AA-1230F90494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1AA62AA-0487-4F89-9B32-FF7A9180CF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7D24B5-B44C-47E0-B88A-E1FFD9549E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9F0D9C-AB88-4647-8136-1878052EC23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D8F019-5C13-492F-AC6F-C03DD570EA4A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051702-21DC-4DCD-ABCB-080D9C9F49B6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23"/>
          <p:cNvSpPr/>
          <p:nvPr/>
        </p:nvSpPr>
        <p:spPr>
          <a:xfrm>
            <a:off x="1428840" y="588492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4"/>
          <p:cNvSpPr/>
          <p:nvPr/>
        </p:nvSpPr>
        <p:spPr>
          <a:xfrm>
            <a:off x="1488960" y="201456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本框 63"/>
          <p:cNvSpPr/>
          <p:nvPr/>
        </p:nvSpPr>
        <p:spPr>
          <a:xfrm>
            <a:off x="3946680" y="2092320"/>
            <a:ext cx="1238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Volume (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14"/>
          <p:cNvSpPr/>
          <p:nvPr/>
        </p:nvSpPr>
        <p:spPr>
          <a:xfrm>
            <a:off x="1428840" y="2595600"/>
            <a:ext cx="216036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×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 KOD Buffer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矩形 15"/>
          <p:cNvSpPr/>
          <p:nvPr/>
        </p:nvSpPr>
        <p:spPr>
          <a:xfrm>
            <a:off x="5560920" y="2076480"/>
            <a:ext cx="1621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Final concent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5"/>
          <p:cNvSpPr/>
          <p:nvPr/>
        </p:nvSpPr>
        <p:spPr>
          <a:xfrm>
            <a:off x="1544760" y="1571760"/>
            <a:ext cx="7116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</a:t>
            </a:r>
            <a:r>
              <a:rPr b="1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8 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CR Reaction Mix (Mutant Plasmid Construction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"/>
          <p:cNvSpPr/>
          <p:nvPr/>
        </p:nvSpPr>
        <p:spPr>
          <a:xfrm>
            <a:off x="1746360" y="2122560"/>
            <a:ext cx="10206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Componen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7"/>
          <p:cNvSpPr/>
          <p:nvPr/>
        </p:nvSpPr>
        <p:spPr>
          <a:xfrm>
            <a:off x="1428840" y="2997360"/>
            <a:ext cx="2160360" cy="46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dNTP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8"/>
          <p:cNvSpPr/>
          <p:nvPr/>
        </p:nvSpPr>
        <p:spPr>
          <a:xfrm>
            <a:off x="1428840" y="3398760"/>
            <a:ext cx="216036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MgSO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₄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9"/>
          <p:cNvSpPr/>
          <p:nvPr/>
        </p:nvSpPr>
        <p:spPr>
          <a:xfrm>
            <a:off x="1428840" y="3800520"/>
            <a:ext cx="27828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KOD-Plus-Neo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(1U/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5"/>
          <p:cNvSpPr/>
          <p:nvPr/>
        </p:nvSpPr>
        <p:spPr>
          <a:xfrm>
            <a:off x="5473800" y="2490840"/>
            <a:ext cx="1439640" cy="53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13"/>
          <p:cNvSpPr/>
          <p:nvPr/>
        </p:nvSpPr>
        <p:spPr>
          <a:xfrm>
            <a:off x="5456160" y="2813040"/>
            <a:ext cx="1440000" cy="53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_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22"/>
          <p:cNvSpPr/>
          <p:nvPr/>
        </p:nvSpPr>
        <p:spPr>
          <a:xfrm>
            <a:off x="5473800" y="3314880"/>
            <a:ext cx="1439640" cy="53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——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31"/>
          <p:cNvSpPr/>
          <p:nvPr/>
        </p:nvSpPr>
        <p:spPr>
          <a:xfrm>
            <a:off x="5473800" y="4591080"/>
            <a:ext cx="1439640" cy="53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0.3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67"/>
          <p:cNvSpPr/>
          <p:nvPr/>
        </p:nvSpPr>
        <p:spPr>
          <a:xfrm>
            <a:off x="3745080" y="2649600"/>
            <a:ext cx="143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71"/>
          <p:cNvSpPr/>
          <p:nvPr/>
        </p:nvSpPr>
        <p:spPr>
          <a:xfrm>
            <a:off x="3745080" y="3052800"/>
            <a:ext cx="1439640" cy="541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72"/>
          <p:cNvSpPr/>
          <p:nvPr/>
        </p:nvSpPr>
        <p:spPr>
          <a:xfrm>
            <a:off x="3745080" y="3456000"/>
            <a:ext cx="143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73"/>
          <p:cNvSpPr/>
          <p:nvPr/>
        </p:nvSpPr>
        <p:spPr>
          <a:xfrm>
            <a:off x="3745080" y="3860640"/>
            <a:ext cx="143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直线连接符 1"/>
          <p:cNvSpPr/>
          <p:nvPr/>
        </p:nvSpPr>
        <p:spPr>
          <a:xfrm>
            <a:off x="1488960" y="246708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58"/>
          <p:cNvSpPr/>
          <p:nvPr/>
        </p:nvSpPr>
        <p:spPr>
          <a:xfrm>
            <a:off x="1428840" y="4605480"/>
            <a:ext cx="2160360" cy="46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R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everse primer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（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）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59"/>
          <p:cNvSpPr/>
          <p:nvPr/>
        </p:nvSpPr>
        <p:spPr>
          <a:xfrm>
            <a:off x="3745080" y="4667400"/>
            <a:ext cx="143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.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1"/>
          <p:cNvSpPr/>
          <p:nvPr/>
        </p:nvSpPr>
        <p:spPr>
          <a:xfrm>
            <a:off x="1428840" y="5006880"/>
            <a:ext cx="216036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ABO-WT plasmid(~100ng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2"/>
          <p:cNvSpPr/>
          <p:nvPr/>
        </p:nvSpPr>
        <p:spPr>
          <a:xfrm>
            <a:off x="1428840" y="5410080"/>
            <a:ext cx="2160360" cy="46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ddH₂O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3"/>
          <p:cNvSpPr/>
          <p:nvPr/>
        </p:nvSpPr>
        <p:spPr>
          <a:xfrm>
            <a:off x="3745080" y="5473800"/>
            <a:ext cx="143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32.9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11"/>
          <p:cNvSpPr/>
          <p:nvPr/>
        </p:nvSpPr>
        <p:spPr>
          <a:xfrm>
            <a:off x="5473800" y="5442120"/>
            <a:ext cx="1439640" cy="53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Times New Roman"/>
              </a:rPr>
              <a:t>____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12"/>
          <p:cNvSpPr/>
          <p:nvPr/>
        </p:nvSpPr>
        <p:spPr>
          <a:xfrm>
            <a:off x="1428840" y="4203720"/>
            <a:ext cx="216036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Forward primer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（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）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16"/>
          <p:cNvSpPr/>
          <p:nvPr/>
        </p:nvSpPr>
        <p:spPr>
          <a:xfrm>
            <a:off x="3745080" y="4264200"/>
            <a:ext cx="143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.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17"/>
          <p:cNvSpPr/>
          <p:nvPr/>
        </p:nvSpPr>
        <p:spPr>
          <a:xfrm>
            <a:off x="5473800" y="4165560"/>
            <a:ext cx="1439640" cy="539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0.3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18"/>
          <p:cNvSpPr/>
          <p:nvPr/>
        </p:nvSpPr>
        <p:spPr>
          <a:xfrm>
            <a:off x="5491080" y="3747960"/>
            <a:ext cx="1440000" cy="540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U/5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本框 19"/>
          <p:cNvSpPr/>
          <p:nvPr/>
        </p:nvSpPr>
        <p:spPr>
          <a:xfrm>
            <a:off x="3745080" y="5108400"/>
            <a:ext cx="143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0.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本框 20"/>
          <p:cNvSpPr/>
          <p:nvPr/>
        </p:nvSpPr>
        <p:spPr>
          <a:xfrm>
            <a:off x="5294160" y="5105520"/>
            <a:ext cx="179892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~100 ng/5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6:36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